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792" autoAdjust="0"/>
    <p:restoredTop sz="94660"/>
  </p:normalViewPr>
  <p:slideViewPr>
    <p:cSldViewPr snapToGrid="0">
      <p:cViewPr varScale="1">
        <p:scale>
          <a:sx n="96" d="100"/>
          <a:sy n="96" d="100"/>
        </p:scale>
        <p:origin x="55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0789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028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0629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599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18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9593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553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5717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9758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1008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6309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76BB59-56C2-4AC7-BCCD-92B5D221260F}" type="datetimeFigureOut">
              <a:rPr kumimoji="1" lang="ja-JP" altLang="en-US" smtClean="0"/>
              <a:t>2022/8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ED581B-8B79-49ED-890A-07F24C7420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5566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フリーフォーム 13"/>
          <p:cNvSpPr/>
          <p:nvPr/>
        </p:nvSpPr>
        <p:spPr>
          <a:xfrm>
            <a:off x="5466081" y="1867893"/>
            <a:ext cx="1259839" cy="3122213"/>
          </a:xfrm>
          <a:custGeom>
            <a:avLst/>
            <a:gdLst>
              <a:gd name="connsiteX0" fmla="*/ 629920 w 1259839"/>
              <a:gd name="connsiteY0" fmla="*/ 0 h 3122213"/>
              <a:gd name="connsiteX1" fmla="*/ 744788 w 1259839"/>
              <a:gd name="connsiteY1" fmla="*/ 126386 h 3122213"/>
              <a:gd name="connsiteX2" fmla="*/ 1259839 w 1259839"/>
              <a:gd name="connsiteY2" fmla="*/ 1561106 h 3122213"/>
              <a:gd name="connsiteX3" fmla="*/ 744788 w 1259839"/>
              <a:gd name="connsiteY3" fmla="*/ 2995826 h 3122213"/>
              <a:gd name="connsiteX4" fmla="*/ 629920 w 1259839"/>
              <a:gd name="connsiteY4" fmla="*/ 3122213 h 3122213"/>
              <a:gd name="connsiteX5" fmla="*/ 515051 w 1259839"/>
              <a:gd name="connsiteY5" fmla="*/ 2995826 h 3122213"/>
              <a:gd name="connsiteX6" fmla="*/ 0 w 1259839"/>
              <a:gd name="connsiteY6" fmla="*/ 1561106 h 3122213"/>
              <a:gd name="connsiteX7" fmla="*/ 515051 w 1259839"/>
              <a:gd name="connsiteY7" fmla="*/ 126386 h 3122213"/>
              <a:gd name="connsiteX8" fmla="*/ 629920 w 1259839"/>
              <a:gd name="connsiteY8" fmla="*/ 0 h 31222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259839" h="3122213">
                <a:moveTo>
                  <a:pt x="629920" y="0"/>
                </a:moveTo>
                <a:lnTo>
                  <a:pt x="744788" y="126386"/>
                </a:lnTo>
                <a:cubicBezTo>
                  <a:pt x="1066551" y="516273"/>
                  <a:pt x="1259839" y="1016117"/>
                  <a:pt x="1259839" y="1561106"/>
                </a:cubicBezTo>
                <a:cubicBezTo>
                  <a:pt x="1259839" y="2106095"/>
                  <a:pt x="1066551" y="2605939"/>
                  <a:pt x="744788" y="2995826"/>
                </a:cubicBezTo>
                <a:lnTo>
                  <a:pt x="629920" y="3122213"/>
                </a:lnTo>
                <a:lnTo>
                  <a:pt x="515051" y="2995826"/>
                </a:lnTo>
                <a:cubicBezTo>
                  <a:pt x="193288" y="2605939"/>
                  <a:pt x="0" y="2106095"/>
                  <a:pt x="0" y="1561106"/>
                </a:cubicBezTo>
                <a:cubicBezTo>
                  <a:pt x="0" y="1016117"/>
                  <a:pt x="193288" y="516273"/>
                  <a:pt x="515051" y="126386"/>
                </a:cubicBezTo>
                <a:lnTo>
                  <a:pt x="629920" y="0"/>
                </a:lnTo>
                <a:close/>
              </a:path>
            </a:pathLst>
          </a:custGeom>
          <a:solidFill>
            <a:schemeClr val="accent6">
              <a:lumMod val="60000"/>
              <a:lumOff val="40000"/>
              <a:alpha val="50000"/>
            </a:schemeClr>
          </a:solidFill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1280160" tIns="531949" rIns="629920" bIns="531948" numCol="1" spcCol="1270" anchor="ctr" anchorCtr="0">
            <a:noAutofit/>
          </a:bodyPr>
          <a:lstStyle/>
          <a:p>
            <a:pPr lvl="0" algn="ctr" defTabSz="10668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kumimoji="1" lang="ja-JP" altLang="en-US" sz="2400" i="1" kern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フリーフォーム 12"/>
          <p:cNvSpPr/>
          <p:nvPr/>
        </p:nvSpPr>
        <p:spPr>
          <a:xfrm>
            <a:off x="2214880" y="1173478"/>
            <a:ext cx="3881121" cy="4511040"/>
          </a:xfrm>
          <a:custGeom>
            <a:avLst/>
            <a:gdLst>
              <a:gd name="connsiteX0" fmla="*/ 2255520 w 3881121"/>
              <a:gd name="connsiteY0" fmla="*/ 0 h 4511040"/>
              <a:gd name="connsiteX1" fmla="*/ 3850413 w 3881121"/>
              <a:gd name="connsiteY1" fmla="*/ 660627 h 4511040"/>
              <a:gd name="connsiteX2" fmla="*/ 3881121 w 3881121"/>
              <a:gd name="connsiteY2" fmla="*/ 694414 h 4511040"/>
              <a:gd name="connsiteX3" fmla="*/ 3766252 w 3881121"/>
              <a:gd name="connsiteY3" fmla="*/ 820800 h 4511040"/>
              <a:gd name="connsiteX4" fmla="*/ 3251201 w 3881121"/>
              <a:gd name="connsiteY4" fmla="*/ 2255520 h 4511040"/>
              <a:gd name="connsiteX5" fmla="*/ 3766252 w 3881121"/>
              <a:gd name="connsiteY5" fmla="*/ 3690240 h 4511040"/>
              <a:gd name="connsiteX6" fmla="*/ 3881121 w 3881121"/>
              <a:gd name="connsiteY6" fmla="*/ 3816627 h 4511040"/>
              <a:gd name="connsiteX7" fmla="*/ 3850413 w 3881121"/>
              <a:gd name="connsiteY7" fmla="*/ 3850413 h 4511040"/>
              <a:gd name="connsiteX8" fmla="*/ 2255520 w 3881121"/>
              <a:gd name="connsiteY8" fmla="*/ 4511040 h 4511040"/>
              <a:gd name="connsiteX9" fmla="*/ 0 w 3881121"/>
              <a:gd name="connsiteY9" fmla="*/ 2255520 h 4511040"/>
              <a:gd name="connsiteX10" fmla="*/ 2255520 w 3881121"/>
              <a:gd name="connsiteY10" fmla="*/ 0 h 45110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3881121" h="4511040">
                <a:moveTo>
                  <a:pt x="2255520" y="0"/>
                </a:moveTo>
                <a:cubicBezTo>
                  <a:pt x="2878364" y="0"/>
                  <a:pt x="3442245" y="252458"/>
                  <a:pt x="3850413" y="660627"/>
                </a:cubicBezTo>
                <a:lnTo>
                  <a:pt x="3881121" y="694414"/>
                </a:lnTo>
                <a:lnTo>
                  <a:pt x="3766252" y="820800"/>
                </a:lnTo>
                <a:cubicBezTo>
                  <a:pt x="3444489" y="1210687"/>
                  <a:pt x="3251201" y="1710531"/>
                  <a:pt x="3251201" y="2255520"/>
                </a:cubicBezTo>
                <a:cubicBezTo>
                  <a:pt x="3251201" y="2800509"/>
                  <a:pt x="3444489" y="3300353"/>
                  <a:pt x="3766252" y="3690240"/>
                </a:cubicBezTo>
                <a:lnTo>
                  <a:pt x="3881121" y="3816627"/>
                </a:lnTo>
                <a:lnTo>
                  <a:pt x="3850413" y="3850413"/>
                </a:lnTo>
                <a:cubicBezTo>
                  <a:pt x="3442245" y="4258582"/>
                  <a:pt x="2878364" y="4511040"/>
                  <a:pt x="2255520" y="4511040"/>
                </a:cubicBezTo>
                <a:cubicBezTo>
                  <a:pt x="1009831" y="4511040"/>
                  <a:pt x="0" y="3501209"/>
                  <a:pt x="0" y="2255520"/>
                </a:cubicBezTo>
                <a:cubicBezTo>
                  <a:pt x="0" y="1009831"/>
                  <a:pt x="1009831" y="0"/>
                  <a:pt x="2255520" y="0"/>
                </a:cubicBezTo>
                <a:close/>
              </a:path>
            </a:pathLst>
          </a:custGeom>
          <a:pattFill prst="ltVert">
            <a:fgClr>
              <a:schemeClr val="accent1">
                <a:lumMod val="60000"/>
                <a:lumOff val="40000"/>
              </a:schemeClr>
            </a:fgClr>
            <a:bgClr>
              <a:schemeClr val="bg1"/>
            </a:bgClr>
          </a:pattFill>
          <a:ln w="25400" cmpd="sng"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1280160" tIns="531949" rIns="629920" bIns="531948" numCol="1" spcCol="1270" anchor="ctr" anchorCtr="0">
            <a:noAutofit/>
          </a:bodyPr>
          <a:lstStyle/>
          <a:p>
            <a:pPr lvl="0" algn="ctr" defTabSz="10668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kumimoji="1" lang="ja-JP" altLang="en-US" sz="2400" i="1" kern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フリーフォーム 11"/>
          <p:cNvSpPr/>
          <p:nvPr/>
        </p:nvSpPr>
        <p:spPr>
          <a:xfrm>
            <a:off x="6096000" y="1173478"/>
            <a:ext cx="3881120" cy="4511040"/>
          </a:xfrm>
          <a:custGeom>
            <a:avLst/>
            <a:gdLst>
              <a:gd name="connsiteX0" fmla="*/ 1625600 w 3881120"/>
              <a:gd name="connsiteY0" fmla="*/ 0 h 4511040"/>
              <a:gd name="connsiteX1" fmla="*/ 3881120 w 3881120"/>
              <a:gd name="connsiteY1" fmla="*/ 2255520 h 4511040"/>
              <a:gd name="connsiteX2" fmla="*/ 1625600 w 3881120"/>
              <a:gd name="connsiteY2" fmla="*/ 4511040 h 4511040"/>
              <a:gd name="connsiteX3" fmla="*/ 30707 w 3881120"/>
              <a:gd name="connsiteY3" fmla="*/ 3850413 h 4511040"/>
              <a:gd name="connsiteX4" fmla="*/ 0 w 3881120"/>
              <a:gd name="connsiteY4" fmla="*/ 3816627 h 4511040"/>
              <a:gd name="connsiteX5" fmla="*/ 114868 w 3881120"/>
              <a:gd name="connsiteY5" fmla="*/ 3690240 h 4511040"/>
              <a:gd name="connsiteX6" fmla="*/ 629919 w 3881120"/>
              <a:gd name="connsiteY6" fmla="*/ 2255520 h 4511040"/>
              <a:gd name="connsiteX7" fmla="*/ 114868 w 3881120"/>
              <a:gd name="connsiteY7" fmla="*/ 820800 h 4511040"/>
              <a:gd name="connsiteX8" fmla="*/ 0 w 3881120"/>
              <a:gd name="connsiteY8" fmla="*/ 694414 h 4511040"/>
              <a:gd name="connsiteX9" fmla="*/ 30707 w 3881120"/>
              <a:gd name="connsiteY9" fmla="*/ 660627 h 4511040"/>
              <a:gd name="connsiteX10" fmla="*/ 1625600 w 3881120"/>
              <a:gd name="connsiteY10" fmla="*/ 0 h 45110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3881120" h="4511040">
                <a:moveTo>
                  <a:pt x="1625600" y="0"/>
                </a:moveTo>
                <a:cubicBezTo>
                  <a:pt x="2871289" y="0"/>
                  <a:pt x="3881120" y="1009831"/>
                  <a:pt x="3881120" y="2255520"/>
                </a:cubicBezTo>
                <a:cubicBezTo>
                  <a:pt x="3881120" y="3501209"/>
                  <a:pt x="2871289" y="4511040"/>
                  <a:pt x="1625600" y="4511040"/>
                </a:cubicBezTo>
                <a:cubicBezTo>
                  <a:pt x="1002756" y="4511040"/>
                  <a:pt x="438876" y="4258582"/>
                  <a:pt x="30707" y="3850413"/>
                </a:cubicBezTo>
                <a:lnTo>
                  <a:pt x="0" y="3816627"/>
                </a:lnTo>
                <a:lnTo>
                  <a:pt x="114868" y="3690240"/>
                </a:lnTo>
                <a:cubicBezTo>
                  <a:pt x="436631" y="3300353"/>
                  <a:pt x="629919" y="2800509"/>
                  <a:pt x="629919" y="2255520"/>
                </a:cubicBezTo>
                <a:cubicBezTo>
                  <a:pt x="629919" y="1710531"/>
                  <a:pt x="436631" y="1210687"/>
                  <a:pt x="114868" y="820800"/>
                </a:cubicBezTo>
                <a:lnTo>
                  <a:pt x="0" y="694414"/>
                </a:lnTo>
                <a:lnTo>
                  <a:pt x="30707" y="660627"/>
                </a:lnTo>
                <a:cubicBezTo>
                  <a:pt x="438876" y="252458"/>
                  <a:pt x="1002756" y="0"/>
                  <a:pt x="1625600" y="0"/>
                </a:cubicBezTo>
                <a:close/>
              </a:path>
            </a:pathLst>
          </a:custGeom>
          <a:pattFill prst="ltHorz">
            <a:fgClr>
              <a:schemeClr val="accent1">
                <a:lumMod val="60000"/>
                <a:lumOff val="40000"/>
              </a:schemeClr>
            </a:fgClr>
            <a:bgClr>
              <a:schemeClr val="bg1"/>
            </a:bgClr>
          </a:pattFill>
          <a:ln w="25400" cmpd="sng"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1280160" tIns="531949" rIns="629920" bIns="531948" numCol="1" spcCol="1270" anchor="ctr" anchorCtr="0">
            <a:noAutofit/>
          </a:bodyPr>
          <a:lstStyle/>
          <a:p>
            <a:pPr lvl="0" algn="ctr" defTabSz="10668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kumimoji="1" lang="ja-JP" altLang="en-US" sz="2400" i="1" kern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81751" y="184683"/>
            <a:ext cx="6784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The definition of current tobacco products us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フリーフォーム 14"/>
          <p:cNvSpPr/>
          <p:nvPr/>
        </p:nvSpPr>
        <p:spPr>
          <a:xfrm>
            <a:off x="5402580" y="1867893"/>
            <a:ext cx="1369060" cy="3122214"/>
          </a:xfrm>
          <a:custGeom>
            <a:avLst/>
            <a:gdLst>
              <a:gd name="connsiteX0" fmla="*/ 629920 w 1259839"/>
              <a:gd name="connsiteY0" fmla="*/ 0 h 3122213"/>
              <a:gd name="connsiteX1" fmla="*/ 744788 w 1259839"/>
              <a:gd name="connsiteY1" fmla="*/ 126386 h 3122213"/>
              <a:gd name="connsiteX2" fmla="*/ 1259839 w 1259839"/>
              <a:gd name="connsiteY2" fmla="*/ 1561106 h 3122213"/>
              <a:gd name="connsiteX3" fmla="*/ 744788 w 1259839"/>
              <a:gd name="connsiteY3" fmla="*/ 2995826 h 3122213"/>
              <a:gd name="connsiteX4" fmla="*/ 629920 w 1259839"/>
              <a:gd name="connsiteY4" fmla="*/ 3122213 h 3122213"/>
              <a:gd name="connsiteX5" fmla="*/ 515051 w 1259839"/>
              <a:gd name="connsiteY5" fmla="*/ 2995826 h 3122213"/>
              <a:gd name="connsiteX6" fmla="*/ 0 w 1259839"/>
              <a:gd name="connsiteY6" fmla="*/ 1561106 h 3122213"/>
              <a:gd name="connsiteX7" fmla="*/ 515051 w 1259839"/>
              <a:gd name="connsiteY7" fmla="*/ 126386 h 3122213"/>
              <a:gd name="connsiteX8" fmla="*/ 629920 w 1259839"/>
              <a:gd name="connsiteY8" fmla="*/ 0 h 31222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259839" h="3122213">
                <a:moveTo>
                  <a:pt x="629920" y="0"/>
                </a:moveTo>
                <a:lnTo>
                  <a:pt x="744788" y="126386"/>
                </a:lnTo>
                <a:cubicBezTo>
                  <a:pt x="1066551" y="516273"/>
                  <a:pt x="1259839" y="1016117"/>
                  <a:pt x="1259839" y="1561106"/>
                </a:cubicBezTo>
                <a:cubicBezTo>
                  <a:pt x="1259839" y="2106095"/>
                  <a:pt x="1066551" y="2605939"/>
                  <a:pt x="744788" y="2995826"/>
                </a:cubicBezTo>
                <a:lnTo>
                  <a:pt x="629920" y="3122213"/>
                </a:lnTo>
                <a:lnTo>
                  <a:pt x="515051" y="2995826"/>
                </a:lnTo>
                <a:cubicBezTo>
                  <a:pt x="193288" y="2605939"/>
                  <a:pt x="0" y="2106095"/>
                  <a:pt x="0" y="1561106"/>
                </a:cubicBezTo>
                <a:cubicBezTo>
                  <a:pt x="0" y="1016117"/>
                  <a:pt x="193288" y="516273"/>
                  <a:pt x="515051" y="126386"/>
                </a:cubicBezTo>
                <a:lnTo>
                  <a:pt x="629920" y="0"/>
                </a:lnTo>
                <a:close/>
              </a:path>
            </a:pathLst>
          </a:custGeom>
          <a:pattFill prst="pct5">
            <a:fgClr>
              <a:schemeClr val="accent1"/>
            </a:fgClr>
            <a:bgClr>
              <a:schemeClr val="bg1"/>
            </a:bgClr>
          </a:pattFill>
          <a:ln w="25400" cmpd="sng"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1280160" tIns="531949" rIns="629920" bIns="531948" numCol="1" spcCol="1270" anchor="ctr" anchorCtr="0">
            <a:noAutofit/>
          </a:bodyPr>
          <a:lstStyle/>
          <a:p>
            <a:pPr lvl="0" algn="ctr" defTabSz="10668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kumimoji="1" lang="ja-JP" altLang="en-US" sz="2400" i="1" kern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線コネクタ 3"/>
          <p:cNvCxnSpPr/>
          <p:nvPr/>
        </p:nvCxnSpPr>
        <p:spPr>
          <a:xfrm flipH="1">
            <a:off x="2124050" y="4546890"/>
            <a:ext cx="962660" cy="104420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/>
          <p:cNvSpPr txBox="1"/>
          <p:nvPr/>
        </p:nvSpPr>
        <p:spPr>
          <a:xfrm>
            <a:off x="271780" y="5537359"/>
            <a:ext cx="38404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clusive</a:t>
            </a:r>
            <a:r>
              <a:rPr lang="ja-JP" alt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garette smokers:</a:t>
            </a:r>
          </a:p>
          <a:p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rea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nted </a:t>
            </a:r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tical line pattern</a:t>
            </a:r>
          </a:p>
        </p:txBody>
      </p:sp>
      <p:cxnSp>
        <p:nvCxnSpPr>
          <p:cNvPr id="16" name="直線コネクタ 15"/>
          <p:cNvCxnSpPr/>
          <p:nvPr/>
        </p:nvCxnSpPr>
        <p:spPr>
          <a:xfrm flipH="1" flipV="1">
            <a:off x="9335836" y="4610845"/>
            <a:ext cx="859113" cy="107113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8352997" y="5554333"/>
            <a:ext cx="38269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ve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TP users:</a:t>
            </a:r>
          </a:p>
          <a:p>
            <a:r>
              <a:rPr kumimoji="1"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rea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nted </a:t>
            </a:r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rizontal line pattern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線コネクタ 19"/>
          <p:cNvCxnSpPr/>
          <p:nvPr/>
        </p:nvCxnSpPr>
        <p:spPr>
          <a:xfrm>
            <a:off x="6096000" y="4311888"/>
            <a:ext cx="0" cy="166904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/>
          <p:cNvSpPr txBox="1"/>
          <p:nvPr/>
        </p:nvSpPr>
        <p:spPr>
          <a:xfrm>
            <a:off x="5402580" y="5877498"/>
            <a:ext cx="35458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al </a:t>
            </a:r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rs:</a:t>
            </a:r>
          </a:p>
          <a:p>
            <a:r>
              <a:rPr kumimoji="1"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rea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nted </a:t>
            </a:r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polka dot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tern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フリーフォーム 22"/>
          <p:cNvSpPr/>
          <p:nvPr/>
        </p:nvSpPr>
        <p:spPr>
          <a:xfrm>
            <a:off x="2237740" y="1173479"/>
            <a:ext cx="4511040" cy="4511039"/>
          </a:xfrm>
          <a:custGeom>
            <a:avLst/>
            <a:gdLst>
              <a:gd name="connsiteX0" fmla="*/ 0 w 4511040"/>
              <a:gd name="connsiteY0" fmla="*/ 2255520 h 4511039"/>
              <a:gd name="connsiteX1" fmla="*/ 2255520 w 4511040"/>
              <a:gd name="connsiteY1" fmla="*/ 0 h 4511039"/>
              <a:gd name="connsiteX2" fmla="*/ 4511040 w 4511040"/>
              <a:gd name="connsiteY2" fmla="*/ 2255520 h 4511039"/>
              <a:gd name="connsiteX3" fmla="*/ 2255520 w 4511040"/>
              <a:gd name="connsiteY3" fmla="*/ 4511040 h 4511039"/>
              <a:gd name="connsiteX4" fmla="*/ 0 w 4511040"/>
              <a:gd name="connsiteY4" fmla="*/ 2255520 h 4511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511040" h="4511039">
                <a:moveTo>
                  <a:pt x="0" y="2255520"/>
                </a:moveTo>
                <a:cubicBezTo>
                  <a:pt x="0" y="1009831"/>
                  <a:pt x="1009831" y="0"/>
                  <a:pt x="2255520" y="0"/>
                </a:cubicBezTo>
                <a:cubicBezTo>
                  <a:pt x="3501209" y="0"/>
                  <a:pt x="4511040" y="1009831"/>
                  <a:pt x="4511040" y="2255520"/>
                </a:cubicBezTo>
                <a:cubicBezTo>
                  <a:pt x="4511040" y="3501209"/>
                  <a:pt x="3501209" y="4511040"/>
                  <a:pt x="2255520" y="4511040"/>
                </a:cubicBezTo>
                <a:cubicBezTo>
                  <a:pt x="1009831" y="4511040"/>
                  <a:pt x="0" y="3501209"/>
                  <a:pt x="0" y="2255520"/>
                </a:cubicBezTo>
                <a:close/>
              </a:path>
            </a:pathLst>
          </a:custGeom>
          <a:noFill/>
          <a:ln w="76200" cmpd="dbl">
            <a:solidFill>
              <a:schemeClr val="tx1"/>
            </a:solidFill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629920" tIns="531949" rIns="1280160" bIns="531948" numCol="1" spcCol="1270" anchor="ctr" anchorCtr="0">
            <a:noAutofit/>
          </a:bodyPr>
          <a:lstStyle/>
          <a:p>
            <a:pPr lvl="0" algn="ctr" defTabSz="10668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kumimoji="1" lang="ja-JP" altLang="en-US" sz="2400" i="1" kern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フリーフォーム 23"/>
          <p:cNvSpPr/>
          <p:nvPr/>
        </p:nvSpPr>
        <p:spPr>
          <a:xfrm>
            <a:off x="5466080" y="1173479"/>
            <a:ext cx="4511040" cy="4511039"/>
          </a:xfrm>
          <a:custGeom>
            <a:avLst/>
            <a:gdLst>
              <a:gd name="connsiteX0" fmla="*/ 0 w 4511040"/>
              <a:gd name="connsiteY0" fmla="*/ 2255520 h 4511039"/>
              <a:gd name="connsiteX1" fmla="*/ 2255520 w 4511040"/>
              <a:gd name="connsiteY1" fmla="*/ 0 h 4511039"/>
              <a:gd name="connsiteX2" fmla="*/ 4511040 w 4511040"/>
              <a:gd name="connsiteY2" fmla="*/ 2255520 h 4511039"/>
              <a:gd name="connsiteX3" fmla="*/ 2255520 w 4511040"/>
              <a:gd name="connsiteY3" fmla="*/ 4511040 h 4511039"/>
              <a:gd name="connsiteX4" fmla="*/ 0 w 4511040"/>
              <a:gd name="connsiteY4" fmla="*/ 2255520 h 4511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511040" h="4511039">
                <a:moveTo>
                  <a:pt x="0" y="2255520"/>
                </a:moveTo>
                <a:cubicBezTo>
                  <a:pt x="0" y="1009831"/>
                  <a:pt x="1009831" y="0"/>
                  <a:pt x="2255520" y="0"/>
                </a:cubicBezTo>
                <a:cubicBezTo>
                  <a:pt x="3501209" y="0"/>
                  <a:pt x="4511040" y="1009831"/>
                  <a:pt x="4511040" y="2255520"/>
                </a:cubicBezTo>
                <a:cubicBezTo>
                  <a:pt x="4511040" y="3501209"/>
                  <a:pt x="3501209" y="4511040"/>
                  <a:pt x="2255520" y="4511040"/>
                </a:cubicBezTo>
                <a:cubicBezTo>
                  <a:pt x="1009831" y="4511040"/>
                  <a:pt x="0" y="3501209"/>
                  <a:pt x="0" y="2255520"/>
                </a:cubicBezTo>
                <a:close/>
              </a:path>
            </a:pathLst>
          </a:custGeom>
          <a:noFill/>
          <a:ln w="76200" cmpd="sng">
            <a:solidFill>
              <a:schemeClr val="tx1"/>
            </a:solidFill>
            <a:prstDash val="sysDot"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629920" tIns="531949" rIns="1280160" bIns="531948" numCol="1" spcCol="1270" anchor="ctr" anchorCtr="0">
            <a:noAutofit/>
          </a:bodyPr>
          <a:lstStyle/>
          <a:p>
            <a:pPr lvl="0" algn="ctr" defTabSz="10668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endParaRPr kumimoji="1" lang="ja-JP" altLang="en-US" sz="2400" i="1" kern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線コネクタ 25"/>
          <p:cNvCxnSpPr/>
          <p:nvPr/>
        </p:nvCxnSpPr>
        <p:spPr>
          <a:xfrm flipH="1" flipV="1">
            <a:off x="2129444" y="1727616"/>
            <a:ext cx="475936" cy="45084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/>
          <p:cNvSpPr txBox="1"/>
          <p:nvPr/>
        </p:nvSpPr>
        <p:spPr>
          <a:xfrm>
            <a:off x="81751" y="1063760"/>
            <a:ext cx="33010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arette smokers:</a:t>
            </a:r>
          </a:p>
          <a:p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rea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rounded by double line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線コネクタ 29"/>
          <p:cNvCxnSpPr/>
          <p:nvPr/>
        </p:nvCxnSpPr>
        <p:spPr>
          <a:xfrm flipV="1">
            <a:off x="9568840" y="1650930"/>
            <a:ext cx="619759" cy="41493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/>
          <p:cNvSpPr txBox="1"/>
          <p:nvPr/>
        </p:nvSpPr>
        <p:spPr>
          <a:xfrm>
            <a:off x="9097688" y="1074416"/>
            <a:ext cx="33377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TP users:</a:t>
            </a:r>
          </a:p>
          <a:p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a surrounded by dotted lines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3625354" y="3173078"/>
            <a:ext cx="146887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garettes</a:t>
            </a:r>
            <a:endParaRPr lang="ja-JP" altLang="en-US" sz="2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7057130" y="2380883"/>
            <a:ext cx="2133273" cy="230832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QOS, </a:t>
            </a:r>
            <a:r>
              <a:rPr lang="en-US" altLang="ja-JP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oom</a:t>
            </a:r>
            <a:r>
              <a:rPr lang="en-US" altLang="ja-JP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CH, </a:t>
            </a:r>
            <a:r>
              <a:rPr lang="en-US" altLang="ja-JP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oom</a:t>
            </a:r>
            <a:r>
              <a:rPr lang="en-US" altLang="ja-JP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ch +, </a:t>
            </a:r>
            <a:r>
              <a:rPr lang="en-US" altLang="ja-JP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oom</a:t>
            </a:r>
            <a:r>
              <a:rPr lang="en-US" altLang="ja-JP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, IQOS, </a:t>
            </a:r>
            <a:r>
              <a:rPr lang="en-US" altLang="ja-JP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o</a:t>
            </a:r>
            <a:r>
              <a:rPr lang="en-US" altLang="ja-JP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o</a:t>
            </a:r>
            <a:r>
              <a:rPr lang="en-US" altLang="ja-JP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ns</a:t>
            </a:r>
            <a:r>
              <a:rPr lang="en-US" altLang="ja-JP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ja-JP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ULZE</a:t>
            </a:r>
            <a:endParaRPr lang="ja-JP" altLang="en-US" sz="2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74202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</TotalTime>
  <Words>82</Words>
  <Application>Microsoft Office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do</dc:creator>
  <cp:lastModifiedBy>mido</cp:lastModifiedBy>
  <cp:revision>14</cp:revision>
  <dcterms:created xsi:type="dcterms:W3CDTF">2022-07-24T05:56:56Z</dcterms:created>
  <dcterms:modified xsi:type="dcterms:W3CDTF">2022-08-03T09:44:11Z</dcterms:modified>
</cp:coreProperties>
</file>